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notesMasterIdLst>
    <p:notesMasterId r:id="rId14"/>
  </p:notesMasterIdLst>
  <p:sldIdLst>
    <p:sldId id="257" r:id="rId2"/>
    <p:sldId id="258" r:id="rId3"/>
    <p:sldId id="259" r:id="rId4"/>
    <p:sldId id="285" r:id="rId5"/>
    <p:sldId id="287" r:id="rId6"/>
    <p:sldId id="267" r:id="rId7"/>
    <p:sldId id="284" r:id="rId8"/>
    <p:sldId id="283" r:id="rId9"/>
    <p:sldId id="271" r:id="rId10"/>
    <p:sldId id="272" r:id="rId11"/>
    <p:sldId id="288" r:id="rId12"/>
    <p:sldId id="276" r:id="rId1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rna Dahan" initials="OD" lastIdx="8" clrIdx="0">
    <p:extLst>
      <p:ext uri="{19B8F6BF-5375-455C-9EA6-DF929625EA0E}">
        <p15:presenceInfo xmlns:p15="http://schemas.microsoft.com/office/powerpoint/2012/main" userId="S-1-5-21-1804658725-2003426753-2791822851-525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84" autoAdjust="0"/>
    <p:restoredTop sz="94660"/>
  </p:normalViewPr>
  <p:slideViewPr>
    <p:cSldViewPr snapToGrid="0">
      <p:cViewPr>
        <p:scale>
          <a:sx n="75" d="100"/>
          <a:sy n="75" d="100"/>
        </p:scale>
        <p:origin x="1483" y="-16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commentAuthors" Target="commentAuthors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2419AE-55C3-4591-B74F-915F1E7306DF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882C56-8025-4132-9F89-15731CFDE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709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2200" y="1143000"/>
            <a:ext cx="21336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1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Engineered strains vs all 1000 strains properties</a:t>
            </a:r>
          </a:p>
          <a:p>
            <a:pPr lvl="0"/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Fitness of strains in YPD (x-axis) and </a:t>
            </a:r>
            <a:r>
              <a:rPr lang="en-US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YPEthanol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y-axis) based on </a:t>
            </a:r>
            <a:r>
              <a:rPr lang="en-US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ti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018 (3) paper.</a:t>
            </a:r>
            <a:r>
              <a:rPr lang="en-US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lue dots represents all strains in </a:t>
            </a:r>
            <a:r>
              <a:rPr lang="en-US" sz="1200" b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ti</a:t>
            </a:r>
            <a:r>
              <a:rPr lang="en-US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llection, gray points represents only made strains for this paper</a:t>
            </a:r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SNPs distribution in the collection. </a:t>
            </a:r>
            <a:r>
              <a:rPr lang="en-US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lue histogram represents all strains in </a:t>
            </a:r>
            <a:r>
              <a:rPr lang="en-US" sz="1200" b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ti</a:t>
            </a:r>
            <a:r>
              <a:rPr lang="en-US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llection, gray histogram represents only made strains for this paper</a:t>
            </a:r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</a:t>
            </a:r>
            <a:r>
              <a:rPr lang="en-US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terozygosity level distribution in the collection. </a:t>
            </a:r>
            <a:r>
              <a:rPr lang="en-US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lue histogram represents all strains in </a:t>
            </a:r>
            <a:r>
              <a:rPr lang="en-US" sz="1200" b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ti</a:t>
            </a:r>
            <a:r>
              <a:rPr lang="en-US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llection, gray histogram represents only made strains for this paper</a:t>
            </a:r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4EF172-4561-4DCE-BC91-3B9F1B439CD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16968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2200" y="1143000"/>
            <a:ext cx="21336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Zoom in on barcodes region from the design</a:t>
            </a:r>
          </a:p>
          <a:p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this map, each letter corresponds to ~25nt length sequence. Same letter in different panels means that the same sequence is present in both regions.  (A) </a:t>
            </a:r>
            <a:r>
              <a:rPr lang="en-US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tA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sign, (B) matα design, (C) the two fragments created in the offspring after fusion of the barcodes.</a:t>
            </a:r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erent combinations of sequences can be used to amplify specific regions only for NGS. </a:t>
            </a:r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4EF172-4561-4DCE-BC91-3B9F1B439CD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9212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2200" y="1143000"/>
            <a:ext cx="21336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6. distribution</a:t>
            </a:r>
            <a:r>
              <a:rPr lang="en-US" baseline="0" dirty="0" smtClean="0"/>
              <a:t>s of fitness scores for offspring, matA and </a:t>
            </a:r>
            <a:r>
              <a:rPr lang="en-US" baseline="0" dirty="0" err="1" smtClean="0"/>
              <a:t>matalp</a:t>
            </a:r>
            <a:r>
              <a:rPr lang="en-US" baseline="0" dirty="0" smtClean="0"/>
              <a:t> haploid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4EF172-4561-4DCE-BC91-3B9F1B439CD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5594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2200" y="1143000"/>
            <a:ext cx="21336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aseline="0" dirty="0" smtClean="0"/>
              <a:t>Figure S2. correlation between offspring fitness and different parental fitness calculation. </a:t>
            </a:r>
          </a:p>
          <a:p>
            <a:r>
              <a:rPr lang="en-US" baseline="0" dirty="0" smtClean="0"/>
              <a:t>Experiments were performed in 3 media types; upper panel – Glucose as carbon source, middle </a:t>
            </a:r>
            <a:r>
              <a:rPr lang="en-US" baseline="0" dirty="0" err="1" smtClean="0"/>
              <a:t>pannel</a:t>
            </a:r>
            <a:r>
              <a:rPr lang="en-US" baseline="0" dirty="0" smtClean="0"/>
              <a:t> – Glucose as carbon source + 1.2M Sorbitol, bottom </a:t>
            </a:r>
            <a:r>
              <a:rPr lang="en-US" baseline="0" dirty="0" err="1" smtClean="0"/>
              <a:t>pannel</a:t>
            </a:r>
            <a:r>
              <a:rPr lang="en-US" baseline="0" dirty="0" smtClean="0"/>
              <a:t> – Glycerol as carbon source. Each of the columns represents different assessment of parents’ fitness (from left to right: using matA fitness only, using </a:t>
            </a:r>
            <a:r>
              <a:rPr lang="en-US" baseline="0" dirty="0" err="1" smtClean="0"/>
              <a:t>matalp</a:t>
            </a:r>
            <a:r>
              <a:rPr lang="en-US" baseline="0" dirty="0" smtClean="0"/>
              <a:t> fitness only, using the mean fitness, using minimal fitness, using maximal fitness.</a:t>
            </a:r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Offspring with </a:t>
            </a:r>
            <a:r>
              <a:rPr lang="en-US" dirty="0" err="1" smtClean="0"/>
              <a:t>calcultable</a:t>
            </a:r>
            <a:r>
              <a:rPr lang="en-US" dirty="0" smtClean="0"/>
              <a:t> fitness were binned</a:t>
            </a:r>
            <a:r>
              <a:rPr lang="en-US" baseline="0" dirty="0" smtClean="0"/>
              <a:t> according to their parents’ performance on the different carbon sources. A point representing the median offspring fitness and error bars representing 95% confidence intervals are plotted for each category of parents fitness.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4EF172-4561-4DCE-BC91-3B9F1B439CDC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94000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2200" y="1143000"/>
            <a:ext cx="21336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baseline="0" dirty="0" smtClean="0"/>
              <a:t>Figure S3 – offspring fitness increases with high GD in Glycerol, but decreases in very high G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baseline="0" dirty="0" smtClean="0"/>
              <a:t>Analysis on the continuous data only (offspring that were not extinct during the experiment). </a:t>
            </a:r>
            <a:r>
              <a:rPr lang="en-US" dirty="0" smtClean="0"/>
              <a:t>Offspring were binned</a:t>
            </a:r>
            <a:r>
              <a:rPr lang="en-US" baseline="0" dirty="0" smtClean="0"/>
              <a:t> according to their parents’ genetic distance. A point representing the median offspring fitness and error bars representing 95% confidence intervals are plotted for each category (GD bins are shown on the x axis and were obtained by equally division of the GD range</a:t>
            </a:r>
            <a:r>
              <a:rPr lang="en-US" b="0" dirty="0" smtClean="0"/>
              <a:t>)</a:t>
            </a:r>
            <a:r>
              <a:rPr lang="en-US" b="0" baseline="0" dirty="0" smtClean="0"/>
              <a:t>, Y axis is the average fitness of the offspring as measured in 6 repetitions (see material and methods “Fitness Estimation”). Vertical red lines </a:t>
            </a:r>
            <a:r>
              <a:rPr lang="en-US" b="0" baseline="0" dirty="0" err="1" smtClean="0"/>
              <a:t>seperates</a:t>
            </a:r>
            <a:r>
              <a:rPr lang="en-US" b="0" baseline="0" dirty="0" smtClean="0"/>
              <a:t> the x axis to show the original bins of GD (as shown in Fig1B). Number of offspring per bin is shown at the bottom of each figur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4EF172-4561-4DCE-BC91-3B9F1B439CDC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1188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467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867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839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222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997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950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289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176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584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18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145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1BA470-18CC-48C2-BC52-6599F7DA6DEB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F5F021-8627-4CB5-B380-DCE8B1AC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852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2171733"/>
              </p:ext>
            </p:extLst>
          </p:nvPr>
        </p:nvGraphicFramePr>
        <p:xfrm>
          <a:off x="1124669" y="1572122"/>
          <a:ext cx="4130044" cy="447270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65022">
                  <a:extLst>
                    <a:ext uri="{9D8B030D-6E8A-4147-A177-3AD203B41FA5}">
                      <a16:colId xmlns:a16="http://schemas.microsoft.com/office/drawing/2014/main" val="1564550885"/>
                    </a:ext>
                  </a:extLst>
                </a:gridCol>
                <a:gridCol w="2065022">
                  <a:extLst>
                    <a:ext uri="{9D8B030D-6E8A-4147-A177-3AD203B41FA5}">
                      <a16:colId xmlns:a16="http://schemas.microsoft.com/office/drawing/2014/main" val="3672524037"/>
                    </a:ext>
                  </a:extLst>
                </a:gridCol>
              </a:tblGrid>
              <a:tr h="169486"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t</a:t>
                      </a:r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200" b="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rains (89 strains)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791" marR="41791" marT="20896" marB="2089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t</a:t>
                      </a:r>
                      <a:r>
                        <a:rPr lang="el-GR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n-US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rains (46)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791" marR="41791" marT="20896" marB="20896"/>
                </a:tc>
                <a:extLst>
                  <a:ext uri="{0D108BD9-81ED-4DB2-BD59-A6C34878D82A}">
                    <a16:rowId xmlns:a16="http://schemas.microsoft.com/office/drawing/2014/main" val="595104945"/>
                  </a:ext>
                </a:extLst>
              </a:tr>
              <a:tr h="192238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K1, AIM1, AKB1, AKG1, AKS1, AKV1, ALG1, ALH1, ANE1, AST1, AVK1, BAS1, BBA1, BBI1, BCB1, BEE1, BES1, BHB1, BHC1, BHF1, BHN1, BHT1, BHV1, BIA1, BIM1, BKA1, BKA2, BKE1, BKF1, BKH1, BKT1, BLA1, BLE1, BLE2, BLH1, BLL1, BLP1, BLS1, BLV1, BMA1, BMB1, BMC1, BMH1, BNE1, BNK1, BNP1, BNT1, BPM1, BPQ1, BPT1, BPV1, BQC1, BQG1, BQH1, BQM1, BQR1, BRA1, BRD1, BSB1, BSD2, BSL2, BTH1, BTN1, BTN2, BVK1, CAE1, CCG1, CCQ1, CCV1, CDF1, CDQ1, CEQ1, CFE1, CFR1, CGL1, CGV1, CHD2, CPK1, CQD1, CQF1, CQG1, CQP1, YAB1, YBG1, YBH1, YBW1, YCH1, YCH2, YCM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791" marR="41791" marT="20896" marB="2089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P1, AIM1, AKB1, AKP1, AKV1, ALG1, ANG1, APV1, AST1, BAK1, BBI1, BEH1, BHB1, BHF1, BHM1, BHN1, BKR1, BLA1, BLE1, BLL1, BLN1, BLP1, BLV1, BMA1, BMK1, BNI1, BNK1, BPQ1, BPT1, BQG1, BQH1, BQI1, BQP1, BQQ1, BQR1, BRA1, BRB1, BRC1, BRD1, BSB1, BTH1, CAD1, CCV1, CQD1, YAR1, YBU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791" marR="41791" marT="20896" marB="20896"/>
                </a:tc>
                <a:extLst>
                  <a:ext uri="{0D108BD9-81ED-4DB2-BD59-A6C34878D82A}">
                    <a16:rowId xmlns:a16="http://schemas.microsoft.com/office/drawing/2014/main" val="4283223302"/>
                  </a:ext>
                </a:extLst>
              </a:tr>
            </a:tbl>
          </a:graphicData>
        </a:graphic>
      </p:graphicFrame>
      <p:sp>
        <p:nvSpPr>
          <p:cNvPr id="10" name="Title 1"/>
          <p:cNvSpPr>
            <a:spLocks noGrp="1"/>
          </p:cNvSpPr>
          <p:nvPr>
            <p:ph type="title"/>
          </p:nvPr>
        </p:nvSpPr>
        <p:spPr>
          <a:xfrm>
            <a:off x="157921" y="149757"/>
            <a:ext cx="4805958" cy="605824"/>
          </a:xfrm>
        </p:spPr>
        <p:txBody>
          <a:bodyPr>
            <a:normAutofit/>
          </a:bodyPr>
          <a:lstStyle/>
          <a:p>
            <a:r>
              <a:rPr lang="en-US" sz="2800" dirty="0" smtClean="0"/>
              <a:t>Table S1.</a:t>
            </a:r>
            <a:endParaRPr lang="en-US" sz="2800" dirty="0"/>
          </a:p>
        </p:txBody>
      </p:sp>
      <p:sp>
        <p:nvSpPr>
          <p:cNvPr id="2" name="Rectangle 1"/>
          <p:cNvSpPr/>
          <p:nvPr/>
        </p:nvSpPr>
        <p:spPr>
          <a:xfrm>
            <a:off x="406561" y="840686"/>
            <a:ext cx="610998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 complete list of haploid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ata (left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) and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at</a:t>
            </a:r>
            <a:r>
              <a:rPr lang="el-GR" sz="1200" b="1" dirty="0" smtClean="0"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α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 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right) strains generated in this work.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trains names are taken from Peter </a:t>
            </a:r>
            <a:r>
              <a:rPr lang="en-US" sz="1200" i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et al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. [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52]. </a:t>
            </a:r>
            <a:endParaRPr lang="en-US" sz="1200" dirty="0"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2929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735" r="63713"/>
          <a:stretch/>
        </p:blipFill>
        <p:spPr>
          <a:xfrm>
            <a:off x="146776" y="1223319"/>
            <a:ext cx="3546804" cy="2940908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625" t="10872"/>
          <a:stretch/>
        </p:blipFill>
        <p:spPr>
          <a:xfrm>
            <a:off x="3693580" y="1260389"/>
            <a:ext cx="3164420" cy="290383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6200000">
            <a:off x="-395969" y="2270611"/>
            <a:ext cx="1393267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fspring fitnes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059503" y="3856449"/>
            <a:ext cx="4809330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NPs in mitochondria and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to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uclear genes/total genes length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532892" y="838116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746173" y="838117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cerol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itle 1"/>
          <p:cNvSpPr txBox="1">
            <a:spLocks/>
          </p:cNvSpPr>
          <p:nvPr/>
        </p:nvSpPr>
        <p:spPr>
          <a:xfrm>
            <a:off x="193047" y="-34725"/>
            <a:ext cx="4805958" cy="605824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 smtClean="0"/>
              <a:t>Figure S9.</a:t>
            </a:r>
            <a:endParaRPr lang="en-US" sz="2800" dirty="0"/>
          </a:p>
        </p:txBody>
      </p:sp>
      <p:sp>
        <p:nvSpPr>
          <p:cNvPr id="5" name="Rectangle 4"/>
          <p:cNvSpPr/>
          <p:nvPr/>
        </p:nvSpPr>
        <p:spPr>
          <a:xfrm>
            <a:off x="193047" y="7577086"/>
            <a:ext cx="6430175" cy="15788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9. 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Parental mitochondrial and </a:t>
            </a:r>
            <a:r>
              <a:rPr lang="en-US" sz="1200" b="1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ito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-nuclear GD is positively correlated with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 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tness in glycerol only</a:t>
            </a:r>
            <a:endParaRPr lang="en-US" sz="1200" dirty="0"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lphaUcParenBoth"/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The GD between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ito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-nuclear genes of every pair of parents was calculated using pairwise alignment and is plotted on the x-axis.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tness is plotted on the y-axis. Analysis is shown separately for the different growth conditions glucose (left), and glycerol (right). </a:t>
            </a: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lphaUcParenBoth"/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Correlation between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ito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-nuclear GD (y-axis) and genome wide GD (calculated by </a:t>
            </a:r>
            <a:r>
              <a:rPr lang="en-US" sz="1200" i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Peter et al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. ,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[9],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x-axis). Pearson r = 0.99, p-value = 0.</a:t>
            </a:r>
            <a:endParaRPr lang="en-US" sz="1200" dirty="0"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06"/>
          <a:stretch/>
        </p:blipFill>
        <p:spPr>
          <a:xfrm>
            <a:off x="2204719" y="4308784"/>
            <a:ext cx="2983759" cy="3268302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 rot="16200000">
            <a:off x="1115513" y="5630838"/>
            <a:ext cx="1683473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to-nuclear based GD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534241" y="7262186"/>
            <a:ext cx="190629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D based on entire genom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46776" y="776561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258017" y="4236044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(B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7375526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9797" y="721784"/>
            <a:ext cx="4713605" cy="6057900"/>
          </a:xfrm>
          <a:prstGeom prst="rect">
            <a:avLst/>
          </a:prstGeom>
          <a:noFill/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193047" y="-34725"/>
            <a:ext cx="4805958" cy="605824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 smtClean="0"/>
              <a:t>Figure S10.</a:t>
            </a:r>
            <a:endParaRPr lang="en-US" sz="2800" dirty="0"/>
          </a:p>
        </p:txBody>
      </p:sp>
      <p:sp>
        <p:nvSpPr>
          <p:cNvPr id="7" name="Rectangle 6"/>
          <p:cNvSpPr/>
          <p:nvPr/>
        </p:nvSpPr>
        <p:spPr>
          <a:xfrm>
            <a:off x="0" y="6930369"/>
            <a:ext cx="6858000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. Simplified models of fitness inheritance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ven one locus with two alleles (A and a), there are 2 parental haploids (A or a) and 4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diploid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,Aa,a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a). Considering A as the higher phenotype allele, parents finesses’ are either 0 or 1 and the average parental fitness could be 0, 0.5, or 1. GD between parents is either 0 (AA or aa) or 1 (Aa 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s 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loids fitnes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calculated based on three models – Co-dominance (left), dominance (middle) or recessive (right). Dots represents the average in case more than on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tness is found. In all modes AA has a fitness of 1 and aa has a fitness of 0. In the Co-Dominance mode Aa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ve a fitness of 0.5, while in the Dominance mode Aa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ve a fitness of 1 and in the recessive fitness of 0.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fferent panels uses different characteristic of the parental pairs; top to bottom: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tness as a function of parents’ GD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tness as a function of parental mean fitness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tness as a function of parental minimal fitness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tness as a function of parental maximal fitness. The co-dominance model (yellow background) agrees with the results of glucose, while the dominance model (green background) agrees with the results of the glycerol condition. 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491989" y="1483680"/>
            <a:ext cx="106150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491989" y="2982529"/>
            <a:ext cx="106150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491989" y="4339877"/>
            <a:ext cx="106150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491989" y="5831250"/>
            <a:ext cx="106150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369929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1" b="3679"/>
          <a:stretch/>
        </p:blipFill>
        <p:spPr>
          <a:xfrm>
            <a:off x="208344" y="787079"/>
            <a:ext cx="6424941" cy="6389226"/>
          </a:xfrm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193047" y="-34725"/>
            <a:ext cx="4805958" cy="605824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 smtClean="0"/>
              <a:t>Figure S11.</a:t>
            </a:r>
            <a:endParaRPr lang="en-US" sz="2800" dirty="0"/>
          </a:p>
        </p:txBody>
      </p:sp>
      <p:sp>
        <p:nvSpPr>
          <p:cNvPr id="2" name="Rectangle 1"/>
          <p:cNvSpPr/>
          <p:nvPr/>
        </p:nvSpPr>
        <p:spPr>
          <a:xfrm>
            <a:off x="923516" y="610479"/>
            <a:ext cx="1759352" cy="3819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3972076" y="701399"/>
            <a:ext cx="1759352" cy="3819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3996701" y="3981692"/>
            <a:ext cx="1759352" cy="3819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923516" y="3981692"/>
            <a:ext cx="1759352" cy="3819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1415906" y="838117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746173" y="838117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cerol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-214463" y="3822910"/>
            <a:ext cx="6543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682868" y="7214405"/>
            <a:ext cx="14221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r allele content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266600" y="7793182"/>
            <a:ext cx="6366685" cy="15788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11. 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inor allele content is correlated to parental fitness in Matα in glucose only</a:t>
            </a:r>
            <a:endParaRPr lang="en-US" sz="1200" dirty="0"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aploids parental fitness is plotted against the minor allele content of each parent. Each dot represents a strain and black line represents the linear fit. Experiments were done on either glucose (left panel) or glycerol (right panel). Upper sub plots depict Mat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parents and bottom panel Matα. Pearson R scores and p values are shown in each sub plot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glucose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– Mata: Pearson R= 0.02, p-value = 9E-1, Matα: Pearson R = 0.35, p-value = 4E-2,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glycerol-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ata: Pearson R= -0.03, p-value = 8.5E-1, Matα: Pearson R = 0.01, p-value = 9.5E-)</a:t>
            </a:r>
            <a:endParaRPr lang="en-US" sz="1200" dirty="0"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18779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itle 1"/>
          <p:cNvSpPr>
            <a:spLocks noGrp="1"/>
          </p:cNvSpPr>
          <p:nvPr>
            <p:ph type="title"/>
          </p:nvPr>
        </p:nvSpPr>
        <p:spPr>
          <a:xfrm>
            <a:off x="-87977" y="-85094"/>
            <a:ext cx="4805958" cy="605824"/>
          </a:xfrm>
        </p:spPr>
        <p:txBody>
          <a:bodyPr>
            <a:normAutofit/>
          </a:bodyPr>
          <a:lstStyle/>
          <a:p>
            <a:r>
              <a:rPr lang="en-US" sz="2800" dirty="0" smtClean="0"/>
              <a:t>Figure S1.</a:t>
            </a:r>
            <a:endParaRPr lang="en-US" sz="28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805" t="9460" r="8953"/>
          <a:stretch/>
        </p:blipFill>
        <p:spPr>
          <a:xfrm>
            <a:off x="3377616" y="623510"/>
            <a:ext cx="2970932" cy="3124904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68" t="9460" r="63698"/>
          <a:stretch/>
        </p:blipFill>
        <p:spPr>
          <a:xfrm>
            <a:off x="418011" y="614285"/>
            <a:ext cx="2959605" cy="3124904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56" t="8326" r="36817" b="1134"/>
          <a:stretch/>
        </p:blipFill>
        <p:spPr>
          <a:xfrm>
            <a:off x="2363026" y="3772285"/>
            <a:ext cx="2822065" cy="312490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08264" y="366294"/>
            <a:ext cx="459780" cy="356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(A)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3831015" y="364081"/>
            <a:ext cx="450339" cy="3568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(B)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690418" y="3593866"/>
            <a:ext cx="450339" cy="356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(C)</a:t>
            </a:r>
            <a:endParaRPr lang="en-US" b="1" dirty="0"/>
          </a:p>
        </p:txBody>
      </p:sp>
      <p:sp>
        <p:nvSpPr>
          <p:cNvPr id="7" name="Rectangle 6"/>
          <p:cNvSpPr/>
          <p:nvPr/>
        </p:nvSpPr>
        <p:spPr>
          <a:xfrm>
            <a:off x="-56407" y="6871440"/>
            <a:ext cx="6868046" cy="30654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 S1. Fitness,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Genetic distance between pair of strains (GD) 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eterozygosity level 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mong selected strains compared to all 1,011 strains </a:t>
            </a:r>
            <a:endParaRPr lang="en-US" sz="1200" dirty="0"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tness values, GD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eterozygosity level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re taken from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Peter </a:t>
            </a:r>
            <a:r>
              <a:rPr lang="en-US" sz="1200" i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et al.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[9]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.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A) Fitness of strains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on fermentable carbon source (YPD, x- axis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is plotted against strains fitness on non-fermentable carbon source ( </a:t>
            </a:r>
            <a:r>
              <a:rPr lang="en-US" sz="1200" dirty="0" err="1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YPEthanol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, y-axis. Gray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dots represent all strains in the collection,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red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points represent only strains used in this work.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B) Number of SNPs / kilo-base distribution in the collection.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Gray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istogram represents all strains in the collection,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red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istogram represents only strains used in this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work</a:t>
            </a:r>
            <a:r>
              <a:rPr lang="en-US" sz="1200" dirty="0" smtClean="0">
                <a:solidFill>
                  <a:srgbClr val="FF0000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.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C) Heterozygosity level distribution of original diploid strains (taken from Peter </a:t>
            </a:r>
            <a:r>
              <a:rPr lang="en-US" sz="1200" i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et al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.  [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52])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in the original collection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gray)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nd the strains used in this work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red). </a:t>
            </a:r>
            <a:endParaRPr lang="en-US" sz="1200" dirty="0"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s can be seen, while fitness and GD in the original full collection distributes similarly to the current chosen collection, the strains chosen here are much less heterozygotes. The relative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omozygocity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of our chosen strains guarantees that when these diploids are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porulated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to make the haploid parental strains for mating, the haploids generated from each diploid are as similar genetically to each other as possible.    </a:t>
            </a:r>
            <a:endParaRPr lang="en-US" sz="1200" dirty="0"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95429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itle 1"/>
          <p:cNvSpPr>
            <a:spLocks noGrp="1"/>
          </p:cNvSpPr>
          <p:nvPr>
            <p:ph type="title"/>
          </p:nvPr>
        </p:nvSpPr>
        <p:spPr>
          <a:xfrm>
            <a:off x="193047" y="-34725"/>
            <a:ext cx="4805958" cy="605824"/>
          </a:xfrm>
        </p:spPr>
        <p:txBody>
          <a:bodyPr>
            <a:normAutofit/>
          </a:bodyPr>
          <a:lstStyle/>
          <a:p>
            <a:r>
              <a:rPr lang="en-US" sz="2800" dirty="0" smtClean="0"/>
              <a:t>Figure S2.</a:t>
            </a:r>
            <a:endParaRPr lang="en-US" sz="28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047" y="571099"/>
            <a:ext cx="6349798" cy="4704364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0" y="5307818"/>
            <a:ext cx="6858000" cy="45981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 S2. Design maps that are used for strains’ engineering</a:t>
            </a:r>
            <a:endParaRPr lang="en-US" sz="1200" dirty="0"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lphaUcParenBoth"/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Top panel – construct designed for creating Mat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strains, bottom panel – construct design for creating matα strains.</a:t>
            </a:r>
          </a:p>
          <a:p>
            <a:pPr indent="228600"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Each of the two constructs was composed from 5 regions (marked I to V) as detailed bellow. </a:t>
            </a: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romanUcPeriod"/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790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bp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upstream to the HO start site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was used for homologous recombination to the HO locus after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transformation.</a:t>
            </a:r>
            <a:endParaRPr lang="en-US" sz="1200" dirty="0"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romanUcPeriod"/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The Barcode Fusion Genetics system that is composed of the barcodes and </a:t>
            </a:r>
            <a:r>
              <a:rPr lang="en-US" sz="1200" i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lox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sequences (see maps in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pan</a:t>
            </a:r>
            <a:r>
              <a:rPr lang="en-US" sz="1200" strike="sngStrike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el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B) and the Tet-ON system. Mat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strains contain the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Cre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enzyme that is regulated by the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rtTA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inducer that is found on the Matα design.</a:t>
            </a: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romanUcPeriod"/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electable markers and florescent proteins. Mat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contains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yeGFP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g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resistance cassette, while Matα contains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Cherry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and NAT resistance cassette.</a:t>
            </a: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romanUcPeriod"/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aploids mating type specific markers. Mat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cells contain the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BleoR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resistance markers for growth on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Zeocin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under the control of Mat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specific promoter (ste2), while matα strains contain the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KanMX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resistance marker for growth on Kanamycin (G418) under the control of Matα specific promoter (ste3).</a:t>
            </a: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romanUcPeriod"/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350 </a:t>
            </a:r>
            <a:r>
              <a:rPr lang="en-US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bp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downstream to the HO stop site was used for homologous recombination to the HO locus after transformation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.</a:t>
            </a:r>
          </a:p>
          <a:p>
            <a:pPr lvl="0"/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Detailed high resolution on genetic architecture of barcodes cassette.</a:t>
            </a:r>
          </a:p>
          <a:p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In this map, each letter corresponds to ~25nt length sequence. Same letter in different panels means that the same sequence is present in both regions.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Upper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panel Mat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design, middle panel matα design, lower panel the two fragments created in the offspring after fusion of the barcodes.</a:t>
            </a:r>
          </a:p>
          <a:p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Different combinations of sequences can be used to amplify specific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regions for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NGS. The BFG system and sequence maps were kindly given to us by the Roth lab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[60].</a:t>
            </a:r>
            <a:endParaRPr lang="en-US" sz="1200" dirty="0"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8815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7725" y="1018139"/>
            <a:ext cx="3988711" cy="3562003"/>
          </a:xfr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193047" y="-34725"/>
            <a:ext cx="4805958" cy="60582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 smtClean="0"/>
              <a:t>Figure S3.</a:t>
            </a:r>
            <a:endParaRPr lang="en-US" sz="2800" dirty="0"/>
          </a:p>
        </p:txBody>
      </p:sp>
      <p:sp>
        <p:nvSpPr>
          <p:cNvPr id="6" name="Rectangle 5"/>
          <p:cNvSpPr/>
          <p:nvPr/>
        </p:nvSpPr>
        <p:spPr>
          <a:xfrm>
            <a:off x="0" y="5307818"/>
            <a:ext cx="6858000" cy="9417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3. 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ybrids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ppearance in the different conditions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This analysis was done on the extinct and continuous data only. 993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s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re found in the glucose condition, 1573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s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re found in the glucose+1.2M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orbitol condition, and 1269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s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re found in the glycerol condition. 569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s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re found in all 3 conditions. </a:t>
            </a:r>
            <a:endParaRPr lang="en-US" sz="1200" dirty="0"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762000" y="1034302"/>
            <a:ext cx="5171440" cy="354584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4999005" y="740111"/>
            <a:ext cx="9028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n = 4094</a:t>
            </a:r>
            <a:endParaRPr lang="en-US" sz="1600" i="1" dirty="0"/>
          </a:p>
        </p:txBody>
      </p:sp>
      <p:sp>
        <p:nvSpPr>
          <p:cNvPr id="7" name="TextBox 6"/>
          <p:cNvSpPr txBox="1"/>
          <p:nvPr/>
        </p:nvSpPr>
        <p:spPr>
          <a:xfrm>
            <a:off x="4346146" y="4288528"/>
            <a:ext cx="15872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Not seen, </a:t>
            </a:r>
            <a:r>
              <a:rPr lang="en-US" sz="1400" i="1" dirty="0" smtClean="0"/>
              <a:t>n = </a:t>
            </a:r>
            <a:r>
              <a:rPr lang="he-IL" sz="1400" i="1" dirty="0" smtClean="0"/>
              <a:t>2142</a:t>
            </a:r>
            <a:endParaRPr lang="en-US" sz="1400" i="1" dirty="0"/>
          </a:p>
        </p:txBody>
      </p:sp>
    </p:spTree>
    <p:extLst>
      <p:ext uri="{BB962C8B-B14F-4D97-AF65-F5344CB8AC3E}">
        <p14:creationId xmlns:p14="http://schemas.microsoft.com/office/powerpoint/2010/main" val="13973813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0" y="-10085"/>
            <a:ext cx="4805958" cy="60582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 smtClean="0"/>
              <a:t>Figure S4.</a:t>
            </a:r>
            <a:endParaRPr lang="en-US" sz="2800" dirty="0"/>
          </a:p>
        </p:txBody>
      </p:sp>
      <p:sp>
        <p:nvSpPr>
          <p:cNvPr id="6" name="Rectangle 5"/>
          <p:cNvSpPr/>
          <p:nvPr/>
        </p:nvSpPr>
        <p:spPr>
          <a:xfrm>
            <a:off x="0" y="8398496"/>
            <a:ext cx="6858000" cy="17912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4.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Correlations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of fitness and strains’ similarities between repetitions and conditions</a:t>
            </a:r>
          </a:p>
          <a:p>
            <a:pPr marL="228600" indent="-228600">
              <a:lnSpc>
                <a:spcPct val="115000"/>
              </a:lnSpc>
              <a:spcAft>
                <a:spcPts val="0"/>
              </a:spcAft>
              <a:buAutoNum type="alphaUcParenBoth"/>
            </a:pPr>
            <a:r>
              <a:rPr lang="en-US" sz="1200" dirty="0" smtClean="0"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Clustering based on the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tness values of all repeats in all three conditions was performed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based on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Pearson correlation. </a:t>
            </a:r>
            <a:r>
              <a:rPr lang="en-US" sz="1200" dirty="0" err="1" smtClean="0"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Dendrograms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are shown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on top and on the left of the figure, while the color represents the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earson correlation value. (all </a:t>
            </a:r>
            <a:r>
              <a:rPr lang="en-US" sz="1200" dirty="0" err="1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Pvalues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&lt; 1E-10)</a:t>
            </a:r>
          </a:p>
          <a:p>
            <a:pPr marL="228600" indent="-228600">
              <a:lnSpc>
                <a:spcPct val="115000"/>
              </a:lnSpc>
              <a:spcAft>
                <a:spcPts val="0"/>
              </a:spcAft>
              <a:buAutoNum type="alphaUcParenBoth"/>
            </a:pP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Clustering based on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s’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identity in the different repeats of all three conditions based on a </a:t>
            </a:r>
            <a:r>
              <a:rPr lang="en-US" sz="1200" dirty="0" err="1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Jaccard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score (intersection/union of the strains in the different pairs of repeats). </a:t>
            </a:r>
            <a:r>
              <a:rPr lang="en-US" sz="1200" dirty="0" err="1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Dendrogram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are shown on top and on the left of the figure, color corresponds </a:t>
            </a:r>
            <a:r>
              <a:rPr lang="en-US" sz="1200" dirty="0" err="1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ro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Jaccard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score. </a:t>
            </a:r>
          </a:p>
          <a:p>
            <a:pPr marL="228600" indent="-228600">
              <a:lnSpc>
                <a:spcPct val="115000"/>
              </a:lnSpc>
              <a:spcAft>
                <a:spcPts val="0"/>
              </a:spcAft>
              <a:buAutoNum type="alphaUcParenBoth"/>
            </a:pPr>
            <a:endParaRPr lang="en-US" sz="1200" dirty="0"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473" y="4526019"/>
            <a:ext cx="4737342" cy="396000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358200" y="555595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A)</a:t>
            </a:r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358200" y="4566765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B)</a:t>
            </a:r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816980" y="384639"/>
            <a:ext cx="7736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Pearson r</a:t>
            </a:r>
            <a:endParaRPr lang="en-US" sz="1200" dirty="0"/>
          </a:p>
        </p:txBody>
      </p:sp>
      <p:sp>
        <p:nvSpPr>
          <p:cNvPr id="31" name="TextBox 30"/>
          <p:cNvSpPr txBox="1"/>
          <p:nvPr/>
        </p:nvSpPr>
        <p:spPr>
          <a:xfrm>
            <a:off x="762789" y="4349592"/>
            <a:ext cx="10227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Jaccard</a:t>
            </a:r>
            <a:r>
              <a:rPr lang="en-US" sz="1200" dirty="0" smtClean="0"/>
              <a:t> Score</a:t>
            </a:r>
            <a:endParaRPr lang="en-US" sz="1200" dirty="0"/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12" b="4856"/>
          <a:stretch/>
        </p:blipFill>
        <p:spPr>
          <a:xfrm>
            <a:off x="948865" y="602333"/>
            <a:ext cx="4618816" cy="3786788"/>
          </a:xfrm>
          <a:prstGeom prst="rect">
            <a:avLst/>
          </a:prstGeom>
        </p:spPr>
      </p:pic>
      <p:cxnSp>
        <p:nvCxnSpPr>
          <p:cNvPr id="27" name="Straight Connector 26"/>
          <p:cNvCxnSpPr/>
          <p:nvPr/>
        </p:nvCxnSpPr>
        <p:spPr>
          <a:xfrm>
            <a:off x="193047" y="4428917"/>
            <a:ext cx="62246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763868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le 1"/>
          <p:cNvSpPr txBox="1">
            <a:spLocks/>
          </p:cNvSpPr>
          <p:nvPr/>
        </p:nvSpPr>
        <p:spPr>
          <a:xfrm>
            <a:off x="193047" y="-34725"/>
            <a:ext cx="4805958" cy="605824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 smtClean="0"/>
              <a:t>Figure S5.</a:t>
            </a:r>
            <a:endParaRPr lang="en-US" sz="28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2" t="8143" b="8292"/>
          <a:stretch/>
        </p:blipFill>
        <p:spPr>
          <a:xfrm>
            <a:off x="1503680" y="568960"/>
            <a:ext cx="4511040" cy="1970978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5" t="7834" b="8790"/>
          <a:stretch/>
        </p:blipFill>
        <p:spPr>
          <a:xfrm>
            <a:off x="1473200" y="2574069"/>
            <a:ext cx="4541520" cy="1966511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0" t="8171" b="8790"/>
          <a:stretch/>
        </p:blipFill>
        <p:spPr>
          <a:xfrm>
            <a:off x="1483360" y="4701602"/>
            <a:ext cx="4530810" cy="1958319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3464560" y="6659921"/>
            <a:ext cx="7232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</a:t>
            </a:r>
            <a:endParaRPr 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326640" y="278710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460233" y="297453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cerol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751840" y="3332480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count</a:t>
            </a:r>
          </a:p>
        </p:txBody>
      </p:sp>
      <p:sp>
        <p:nvSpPr>
          <p:cNvPr id="20" name="Rectangle 19"/>
          <p:cNvSpPr/>
          <p:nvPr/>
        </p:nvSpPr>
        <p:spPr>
          <a:xfrm>
            <a:off x="53340" y="7679195"/>
            <a:ext cx="6822440" cy="11541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5. 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Distributions of fitness scores for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s diploids,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ata 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at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aploids</a:t>
            </a:r>
            <a:endParaRPr lang="en-US" sz="1200" dirty="0"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istograms of fitness scores were calculated for each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nd each of the haploid parent based on its frequency during the pooled competition in each of the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two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growth conditions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competitions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were done separately for diploids and each of the two haploid mating types) (see Materials &amp; Methods). Top-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s,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iddle – Mat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, bottom – matα; left – glucose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right - glycerol</a:t>
            </a:r>
            <a:endParaRPr lang="en-US" sz="1200" dirty="0"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6502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730" t="9177" b="7041"/>
          <a:stretch/>
        </p:blipFill>
        <p:spPr>
          <a:xfrm>
            <a:off x="3511932" y="990569"/>
            <a:ext cx="3346068" cy="280876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95" r="66117" b="7269"/>
          <a:stretch/>
        </p:blipFill>
        <p:spPr>
          <a:xfrm>
            <a:off x="193716" y="990569"/>
            <a:ext cx="3345653" cy="2808763"/>
          </a:xfrm>
          <a:prstGeom prst="rect">
            <a:avLst/>
          </a:prstGeo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193047" y="-34725"/>
            <a:ext cx="4805958" cy="605824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 smtClean="0"/>
              <a:t>Figure S6.</a:t>
            </a:r>
            <a:endParaRPr lang="en-US" sz="2800" dirty="0"/>
          </a:p>
        </p:txBody>
      </p:sp>
      <p:sp>
        <p:nvSpPr>
          <p:cNvPr id="3" name="TextBox 2"/>
          <p:cNvSpPr txBox="1"/>
          <p:nvPr/>
        </p:nvSpPr>
        <p:spPr>
          <a:xfrm rot="16200000">
            <a:off x="-276956" y="2241061"/>
            <a:ext cx="1091966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l-GR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157124" y="3874959"/>
            <a:ext cx="1077539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47811" y="692286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727644" y="692285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cerol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0" y="4263950"/>
            <a:ext cx="674286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s between conditions and strain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represents a haploid strain from strains that both Mata and matα were made and used. X axis is fitness of Mata, y axis is fitness of matα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d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y strains for which both mating types have calculable fitness data. Left – glucose; right glycerol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arson R: glucose – 0.56, glycerol – 0.2</a:t>
            </a:r>
          </a:p>
        </p:txBody>
      </p:sp>
    </p:spTree>
    <p:extLst>
      <p:ext uri="{BB962C8B-B14F-4D97-AF65-F5344CB8AC3E}">
        <p14:creationId xmlns:p14="http://schemas.microsoft.com/office/powerpoint/2010/main" val="16085014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 rot="19002787">
            <a:off x="5066410" y="4541293"/>
            <a:ext cx="6912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l-GR" sz="800" dirty="0" smtClean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</a:p>
        </p:txBody>
      </p:sp>
      <p:sp>
        <p:nvSpPr>
          <p:cNvPr id="13" name="TextBox 12"/>
          <p:cNvSpPr txBox="1"/>
          <p:nvPr/>
        </p:nvSpPr>
        <p:spPr>
          <a:xfrm rot="19002787">
            <a:off x="5063264" y="4615920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l-GR" sz="8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 fitness</a:t>
            </a:r>
          </a:p>
        </p:txBody>
      </p:sp>
      <p:sp>
        <p:nvSpPr>
          <p:cNvPr id="14" name="TextBox 13"/>
          <p:cNvSpPr txBox="1"/>
          <p:nvPr/>
        </p:nvSpPr>
        <p:spPr>
          <a:xfrm rot="19002787">
            <a:off x="4909016" y="4751221"/>
            <a:ext cx="12378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l-GR" sz="8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mediate fitness</a:t>
            </a:r>
          </a:p>
        </p:txBody>
      </p:sp>
      <p:sp>
        <p:nvSpPr>
          <p:cNvPr id="15" name="TextBox 14"/>
          <p:cNvSpPr txBox="1"/>
          <p:nvPr/>
        </p:nvSpPr>
        <p:spPr>
          <a:xfrm rot="19002787">
            <a:off x="5356498" y="4624308"/>
            <a:ext cx="9092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l-GR" sz="8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fitness</a:t>
            </a: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278" t="80576" b="3024"/>
          <a:stretch/>
        </p:blipFill>
        <p:spPr>
          <a:xfrm>
            <a:off x="165848" y="4421587"/>
            <a:ext cx="2032450" cy="908304"/>
          </a:xfrm>
          <a:prstGeom prst="parallelogram">
            <a:avLst>
              <a:gd name="adj" fmla="val 40254"/>
            </a:avLst>
          </a:prstGeom>
        </p:spPr>
      </p:pic>
      <p:sp>
        <p:nvSpPr>
          <p:cNvPr id="18" name="Title 1"/>
          <p:cNvSpPr txBox="1">
            <a:spLocks/>
          </p:cNvSpPr>
          <p:nvPr/>
        </p:nvSpPr>
        <p:spPr>
          <a:xfrm>
            <a:off x="193047" y="-34725"/>
            <a:ext cx="4805958" cy="605824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 smtClean="0"/>
              <a:t>Figure S7.</a:t>
            </a:r>
            <a:endParaRPr lang="en-US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759946" y="732881"/>
            <a:ext cx="1324402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n parental fitness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138175" y="732881"/>
            <a:ext cx="1242649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 parental fitness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447075" y="727381"/>
            <a:ext cx="1265091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x parental fitness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825132" y="724811"/>
            <a:ext cx="713232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n-US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278" t="80576" b="3024"/>
          <a:stretch/>
        </p:blipFill>
        <p:spPr>
          <a:xfrm>
            <a:off x="1498172" y="4388633"/>
            <a:ext cx="2032450" cy="908304"/>
          </a:xfrm>
          <a:prstGeom prst="parallelogram">
            <a:avLst>
              <a:gd name="adj" fmla="val 68442"/>
            </a:avLst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278" t="80576" b="3024"/>
          <a:stretch/>
        </p:blipFill>
        <p:spPr>
          <a:xfrm>
            <a:off x="2771156" y="4381894"/>
            <a:ext cx="2032450" cy="908304"/>
          </a:xfrm>
          <a:prstGeom prst="parallelogram">
            <a:avLst>
              <a:gd name="adj" fmla="val 68442"/>
            </a:avLst>
          </a:prstGeom>
        </p:spPr>
      </p:pic>
      <p:sp>
        <p:nvSpPr>
          <p:cNvPr id="30" name="TextBox 29"/>
          <p:cNvSpPr txBox="1"/>
          <p:nvPr/>
        </p:nvSpPr>
        <p:spPr>
          <a:xfrm rot="19002787">
            <a:off x="4319290" y="4520824"/>
            <a:ext cx="6880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n-US" sz="8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</a:p>
        </p:txBody>
      </p:sp>
      <p:sp>
        <p:nvSpPr>
          <p:cNvPr id="31" name="TextBox 30"/>
          <p:cNvSpPr txBox="1"/>
          <p:nvPr/>
        </p:nvSpPr>
        <p:spPr>
          <a:xfrm rot="19002787">
            <a:off x="4329781" y="4595451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n-US" sz="8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 fitness</a:t>
            </a:r>
          </a:p>
        </p:txBody>
      </p:sp>
      <p:sp>
        <p:nvSpPr>
          <p:cNvPr id="32" name="TextBox 31"/>
          <p:cNvSpPr txBox="1"/>
          <p:nvPr/>
        </p:nvSpPr>
        <p:spPr>
          <a:xfrm rot="19002787">
            <a:off x="4164301" y="4730752"/>
            <a:ext cx="1229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n-US" sz="8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mediate fitness</a:t>
            </a:r>
          </a:p>
        </p:txBody>
      </p:sp>
      <p:sp>
        <p:nvSpPr>
          <p:cNvPr id="33" name="TextBox 32"/>
          <p:cNvSpPr txBox="1"/>
          <p:nvPr/>
        </p:nvSpPr>
        <p:spPr>
          <a:xfrm rot="19002787">
            <a:off x="4616061" y="4603839"/>
            <a:ext cx="9028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n-US" sz="8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fitness</a:t>
            </a:r>
          </a:p>
        </p:txBody>
      </p:sp>
      <p:sp>
        <p:nvSpPr>
          <p:cNvPr id="34" name="Rectangle 1"/>
          <p:cNvSpPr>
            <a:spLocks noChangeArrowheads="1"/>
          </p:cNvSpPr>
          <p:nvPr/>
        </p:nvSpPr>
        <p:spPr bwMode="auto">
          <a:xfrm>
            <a:off x="196700" y="5425988"/>
            <a:ext cx="6368248" cy="24929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 S7. Correlation between 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 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tness and different definitions of parental fitness 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Experiments were performed in three media types; upper panel – glucose as carbon source, middle panel – glucose as carbon sources + osmotic stress (1.2M sorbitol) bottom panel – glycerol as carbon source. </a:t>
            </a:r>
            <a:r>
              <a:rPr lang="en-US" alt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nalysis on the calculable fitness data only. 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Each of the columns represents different assessment of parents’ fitness (using the mean fitness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of</a:t>
            </a:r>
            <a:r>
              <a:rPr kumimoji="0" lang="en-US" altLang="en-US" sz="1200" b="0" i="0" u="none" strike="noStrike" cap="none" normalizeH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both parents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A), using the fitness of the parent with the minimal fitness (B), using the fitness of the parent with the maximal fitness (C), </a:t>
            </a:r>
            <a:r>
              <a:rPr lang="en-US" alt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using </a:t>
            </a:r>
            <a:r>
              <a:rPr lang="en-US" alt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at</a:t>
            </a:r>
            <a:r>
              <a:rPr lang="en-US" alt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</a:t>
            </a:r>
            <a:r>
              <a:rPr lang="en-US" alt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tness </a:t>
            </a:r>
            <a:r>
              <a:rPr lang="en-US" alt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only (D), </a:t>
            </a:r>
            <a:r>
              <a:rPr lang="en-US" alt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using </a:t>
            </a:r>
            <a:r>
              <a:rPr lang="en-US" alt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atα </a:t>
            </a:r>
            <a:r>
              <a:rPr lang="en-US" alt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tness </a:t>
            </a:r>
            <a:r>
              <a:rPr lang="en-US" altLang="en-US" sz="1200" dirty="0" smtClean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only (E)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.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Each subplot presents the correlation between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tness (y axis) and parental fitness (x axis) calculated as define above. 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s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were binned according to their parents’ performance on the different carbon sources. A point representing the median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tness and error bars representing 95% confidence intervals are plotted for each category of parents’ </a:t>
            </a:r>
            <a:r>
              <a:rPr kumimoji="0" lang="en-US" altLang="en-US" sz="12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tness.</a:t>
            </a:r>
            <a:r>
              <a:rPr lang="en-US" altLang="en-US" sz="1200" dirty="0" smtClean="0">
                <a:solidFill>
                  <a:srgbClr val="008080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200" b="0" i="0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Numbers is bracket indicate the number of </a:t>
            </a:r>
            <a:r>
              <a:rPr kumimoji="0" lang="en-US" altLang="en-US" sz="1200" b="0" i="0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hybrids</a:t>
            </a:r>
            <a:r>
              <a:rPr kumimoji="0" lang="en-US" altLang="en-US" sz="1200" b="0" i="0" strike="noStrike" cap="none" normalizeH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200" b="0" i="0" strike="noStrike" cap="none" normalizeH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in each category. </a:t>
            </a:r>
            <a:r>
              <a:rPr kumimoji="0" lang="en-US" altLang="en-US" sz="1200" b="0" i="0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</a:t>
            </a:r>
            <a:endParaRPr kumimoji="0" lang="en-US" altLang="en-US" sz="1200" b="0" i="0" strike="noStrike" cap="none" normalizeH="0" baseline="0" dirty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443242" y="742097"/>
            <a:ext cx="713232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l-GR" sz="1050" dirty="0" smtClean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759946" y="957580"/>
            <a:ext cx="5484221" cy="1295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 rot="16200000">
            <a:off x="-124127" y="2672400"/>
            <a:ext cx="1061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35268" y="447826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A)</a:t>
            </a:r>
            <a:endParaRPr lang="en-US" dirty="0"/>
          </a:p>
        </p:txBody>
      </p:sp>
      <p:sp>
        <p:nvSpPr>
          <p:cNvPr id="44" name="TextBox 43"/>
          <p:cNvSpPr txBox="1"/>
          <p:nvPr/>
        </p:nvSpPr>
        <p:spPr>
          <a:xfrm>
            <a:off x="2050482" y="431415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B)</a:t>
            </a:r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>
            <a:off x="3426832" y="431415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C)</a:t>
            </a:r>
            <a:endParaRPr lang="en-US" dirty="0"/>
          </a:p>
        </p:txBody>
      </p:sp>
      <p:sp>
        <p:nvSpPr>
          <p:cNvPr id="46" name="TextBox 45"/>
          <p:cNvSpPr txBox="1"/>
          <p:nvPr/>
        </p:nvSpPr>
        <p:spPr>
          <a:xfrm>
            <a:off x="4690800" y="414420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D)</a:t>
            </a:r>
            <a:endParaRPr lang="en-US" dirty="0"/>
          </a:p>
        </p:txBody>
      </p:sp>
      <p:sp>
        <p:nvSpPr>
          <p:cNvPr id="47" name="TextBox 46"/>
          <p:cNvSpPr txBox="1"/>
          <p:nvPr/>
        </p:nvSpPr>
        <p:spPr>
          <a:xfrm>
            <a:off x="5438497" y="384950"/>
            <a:ext cx="437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(E)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9" t="4059" r="29682" b="4248"/>
          <a:stretch/>
        </p:blipFill>
        <p:spPr>
          <a:xfrm>
            <a:off x="640080" y="1170331"/>
            <a:ext cx="4738196" cy="3280205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534" t="4059" r="8996" b="4248"/>
          <a:stretch/>
        </p:blipFill>
        <p:spPr>
          <a:xfrm>
            <a:off x="5460539" y="1244829"/>
            <a:ext cx="775504" cy="32067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48107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"/>
          <p:cNvSpPr txBox="1">
            <a:spLocks/>
          </p:cNvSpPr>
          <p:nvPr/>
        </p:nvSpPr>
        <p:spPr>
          <a:xfrm>
            <a:off x="193047" y="-34725"/>
            <a:ext cx="4805958" cy="605824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 smtClean="0"/>
              <a:t>Figure S8.</a:t>
            </a:r>
            <a:endParaRPr lang="en-US" sz="2800" dirty="0"/>
          </a:p>
        </p:txBody>
      </p:sp>
      <p:sp>
        <p:nvSpPr>
          <p:cNvPr id="3" name="Rectangle 2"/>
          <p:cNvSpPr/>
          <p:nvPr/>
        </p:nvSpPr>
        <p:spPr>
          <a:xfrm>
            <a:off x="3117412" y="4023910"/>
            <a:ext cx="223269" cy="11908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885"/>
          <a:stretch/>
        </p:blipFill>
        <p:spPr>
          <a:xfrm>
            <a:off x="542" y="3103584"/>
            <a:ext cx="3567600" cy="1025107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94702" y="8052623"/>
            <a:ext cx="6491958" cy="15788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S8.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Hybrid 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</a:rPr>
              <a:t>fitness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is </a:t>
            </a:r>
            <a:r>
              <a:rPr lang="en-US" sz="1200" b="1" dirty="0">
                <a:latin typeface="Times New Roman" panose="02020603050405020304" pitchFamily="18" charset="0"/>
                <a:ea typeface="Arial" panose="020B0604020202020204" pitchFamily="34" charset="0"/>
              </a:rPr>
              <a:t>maximized at GD of ~1.2 SNPs/kilo-base </a:t>
            </a:r>
            <a:r>
              <a:rPr lang="en-US" sz="1200" b="1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especially in glycerol </a:t>
            </a:r>
            <a:endParaRPr lang="en-US" sz="1200" dirty="0"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Hybrid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</a:rPr>
              <a:t>fitness (y axis) is plotted against binned parental genetic distance (x axis) at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high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</a:rPr>
              <a:t>bin resolution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(relates to Figure 4B).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</a:rPr>
              <a:t>Filled circles represent median fitness of all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hybrids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</a:rPr>
              <a:t>in each GD bin, error bars represents 95% confidence intervals. Numbers bellow each dot mark the number of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hybrids </a:t>
            </a:r>
            <a:r>
              <a:rPr lang="en-US" sz="1200" dirty="0">
                <a:latin typeface="Times New Roman" panose="02020603050405020304" pitchFamily="18" charset="0"/>
                <a:ea typeface="Arial" panose="020B0604020202020204" pitchFamily="34" charset="0"/>
              </a:rPr>
              <a:t>included in each bin. Analysis on the calculable fitness data only (offspring that were not extinct during the experiment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). Red dashes lines corresponds to the separation between the second to third and third to fourth GD bins (as </a:t>
            </a:r>
            <a:r>
              <a:rPr lang="en-US" sz="1200" dirty="0" smtClean="0">
                <a:latin typeface="Times New Roman" panose="02020603050405020304" pitchFamily="18" charset="0"/>
                <a:ea typeface="Arial" panose="020B0604020202020204" pitchFamily="34" charset="0"/>
              </a:rPr>
              <a:t>shown in the multi-model distribution of GDs in Figure 2)</a:t>
            </a:r>
            <a:endParaRPr lang="en-US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885"/>
          <a:stretch/>
        </p:blipFill>
        <p:spPr>
          <a:xfrm>
            <a:off x="3290400" y="3103584"/>
            <a:ext cx="3567600" cy="102510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222" t="7012"/>
          <a:stretch/>
        </p:blipFill>
        <p:spPr>
          <a:xfrm>
            <a:off x="94702" y="4521200"/>
            <a:ext cx="3627129" cy="335661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" t="5781" r="65853" b="24116"/>
          <a:stretch/>
        </p:blipFill>
        <p:spPr>
          <a:xfrm>
            <a:off x="542" y="680720"/>
            <a:ext cx="3472799" cy="2422864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20" t="5488" r="33823" b="24410"/>
          <a:stretch/>
        </p:blipFill>
        <p:spPr>
          <a:xfrm>
            <a:off x="3861343" y="680720"/>
            <a:ext cx="2905218" cy="2422864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" t="-844" r="94589" b="24116"/>
          <a:stretch/>
        </p:blipFill>
        <p:spPr>
          <a:xfrm>
            <a:off x="542" y="4295678"/>
            <a:ext cx="518390" cy="2651842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397056" y="436415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464548" y="4209051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cerol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400999" y="438554"/>
            <a:ext cx="19720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 + 1.2M Sorbitol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-436053" y="1698842"/>
            <a:ext cx="106150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436053" y="5539136"/>
            <a:ext cx="106150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nes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393182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95</TotalTime>
  <Words>2639</Words>
  <Application>Microsoft Office PowerPoint</Application>
  <PresentationFormat>A4 Paper (210x297 mm)</PresentationFormat>
  <Paragraphs>134</Paragraphs>
  <Slides>12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8" baseType="lpstr">
      <vt:lpstr>Arial</vt:lpstr>
      <vt:lpstr>Calibri</vt:lpstr>
      <vt:lpstr>Calibri Light</vt:lpstr>
      <vt:lpstr>Symbol</vt:lpstr>
      <vt:lpstr>Times New Roman</vt:lpstr>
      <vt:lpstr>Office Theme</vt:lpstr>
      <vt:lpstr>Table S1.</vt:lpstr>
      <vt:lpstr>Figure S1.</vt:lpstr>
      <vt:lpstr>Figure S2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S1.</dc:title>
  <dc:creator>User</dc:creator>
  <cp:lastModifiedBy>User</cp:lastModifiedBy>
  <cp:revision>93</cp:revision>
  <dcterms:created xsi:type="dcterms:W3CDTF">2023-05-22T17:20:17Z</dcterms:created>
  <dcterms:modified xsi:type="dcterms:W3CDTF">2024-02-22T08:01:21Z</dcterms:modified>
</cp:coreProperties>
</file>